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3"/>
  </p:normalViewPr>
  <p:slideViewPr>
    <p:cSldViewPr snapToGrid="0" snapToObjects="1" showGuides="1">
      <p:cViewPr varScale="1">
        <p:scale>
          <a:sx n="79" d="100"/>
          <a:sy n="79" d="100"/>
        </p:scale>
        <p:origin x="3064" y="2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D4947-F27D-BA42-B2EC-C30AEB9177F8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6981-1B54-B048-89DA-20DA5CCC1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868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D4947-F27D-BA42-B2EC-C30AEB9177F8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6981-1B54-B048-89DA-20DA5CCC1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707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D4947-F27D-BA42-B2EC-C30AEB9177F8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6981-1B54-B048-89DA-20DA5CCC1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089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D4947-F27D-BA42-B2EC-C30AEB9177F8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6981-1B54-B048-89DA-20DA5CCC1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103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D4947-F27D-BA42-B2EC-C30AEB9177F8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6981-1B54-B048-89DA-20DA5CCC1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78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D4947-F27D-BA42-B2EC-C30AEB9177F8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6981-1B54-B048-89DA-20DA5CCC1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510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D4947-F27D-BA42-B2EC-C30AEB9177F8}" type="datetimeFigureOut">
              <a:rPr lang="en-US" smtClean="0"/>
              <a:t>5/2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6981-1B54-B048-89DA-20DA5CCC1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186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D4947-F27D-BA42-B2EC-C30AEB9177F8}" type="datetimeFigureOut">
              <a:rPr lang="en-US" smtClean="0"/>
              <a:t>5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6981-1B54-B048-89DA-20DA5CCC1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73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D4947-F27D-BA42-B2EC-C30AEB9177F8}" type="datetimeFigureOut">
              <a:rPr lang="en-US" smtClean="0"/>
              <a:t>5/2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6981-1B54-B048-89DA-20DA5CCC1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769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D4947-F27D-BA42-B2EC-C30AEB9177F8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6981-1B54-B048-89DA-20DA5CCC1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227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D4947-F27D-BA42-B2EC-C30AEB9177F8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26981-1B54-B048-89DA-20DA5CCC1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820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D4947-F27D-BA42-B2EC-C30AEB9177F8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C26981-1B54-B048-89DA-20DA5CCC1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273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ED63822-A93E-8048-B262-F718CFC8C9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2909809"/>
              </p:ext>
            </p:extLst>
          </p:nvPr>
        </p:nvGraphicFramePr>
        <p:xfrm>
          <a:off x="304011" y="1568628"/>
          <a:ext cx="6293343" cy="424846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97781">
                  <a:extLst>
                    <a:ext uri="{9D8B030D-6E8A-4147-A177-3AD203B41FA5}">
                      <a16:colId xmlns:a16="http://schemas.microsoft.com/office/drawing/2014/main" val="1331858148"/>
                    </a:ext>
                  </a:extLst>
                </a:gridCol>
                <a:gridCol w="2097781">
                  <a:extLst>
                    <a:ext uri="{9D8B030D-6E8A-4147-A177-3AD203B41FA5}">
                      <a16:colId xmlns:a16="http://schemas.microsoft.com/office/drawing/2014/main" val="2688220260"/>
                    </a:ext>
                  </a:extLst>
                </a:gridCol>
                <a:gridCol w="2097781">
                  <a:extLst>
                    <a:ext uri="{9D8B030D-6E8A-4147-A177-3AD203B41FA5}">
                      <a16:colId xmlns:a16="http://schemas.microsoft.com/office/drawing/2014/main" val="4189755931"/>
                    </a:ext>
                  </a:extLst>
                </a:gridCol>
              </a:tblGrid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ature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sembly 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sembly202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1689570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igs/Chromosome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(23 and </a:t>
                      </a:r>
                      <a:r>
                        <a:rPr lang="en-US" sz="10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DNA</a:t>
                      </a: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7 and </a:t>
                      </a:r>
                      <a:r>
                        <a:rPr lang="en-US" sz="10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DNA</a:t>
                      </a: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7055938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coding gene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5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3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7908598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NA</a:t>
                      </a: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ene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3454644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P density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in 576 </a:t>
                      </a:r>
                      <a:r>
                        <a:rPr lang="en-US" sz="10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 in 388 </a:t>
                      </a:r>
                      <a:r>
                        <a:rPr lang="en-IN" sz="1000" b="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p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8400974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l density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in 1340 </a:t>
                      </a:r>
                      <a:r>
                        <a:rPr lang="en-US" sz="10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7988156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ng heterozygous loci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4754915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rge CNV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5458424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lomere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0672182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length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30139 </a:t>
                      </a:r>
                      <a:r>
                        <a:rPr lang="en-US" sz="10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09527 </a:t>
                      </a:r>
                      <a:r>
                        <a:rPr lang="en-US" sz="10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5524769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5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s-IS" sz="10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654078 bp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4192 </a:t>
                      </a:r>
                      <a:r>
                        <a:rPr lang="en-US" sz="10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5919957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9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8422 </a:t>
                      </a:r>
                      <a:r>
                        <a:rPr lang="en-US" sz="10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39682 </a:t>
                      </a:r>
                      <a:r>
                        <a:rPr lang="en-US" sz="10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9299275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teness (BUSCO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5 out of 131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78 out of 131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2239213"/>
                  </a:ext>
                </a:extLst>
              </a:tr>
              <a:tr h="303462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gap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0465172"/>
                  </a:ext>
                </a:extLst>
              </a:tr>
            </a:tbl>
          </a:graphicData>
        </a:graphic>
      </p:graphicFrame>
      <p:sp>
        <p:nvSpPr>
          <p:cNvPr id="5" name="Rectangle 2">
            <a:extLst>
              <a:ext uri="{FF2B5EF4-FFF2-40B4-BE49-F238E27FC236}">
                <a16:creationId xmlns:a16="http://schemas.microsoft.com/office/drawing/2014/main" id="{8E13CB0E-B7C7-954F-B7EB-036C1DF8E6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0320" y="954033"/>
            <a:ext cx="6293343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pplementary file 4</a:t>
            </a:r>
            <a:r>
              <a:rPr kumimoji="0" lang="en-US" altLang="en-US" sz="10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: A comparative analysis of Assembly A and</a:t>
            </a:r>
            <a:r>
              <a:rPr kumimoji="0" lang="en-US" altLang="en-US" sz="1000" i="0" u="none" strike="noStrike" cap="none" normalizeH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the improved </a:t>
            </a:r>
            <a:r>
              <a:rPr kumimoji="0" lang="en-US" altLang="en-US" sz="10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ssembly2020 of </a:t>
            </a:r>
            <a:r>
              <a:rPr kumimoji="0" lang="en-US" altLang="en-US" sz="1000" i="1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. </a:t>
            </a:r>
            <a:r>
              <a:rPr kumimoji="0" lang="en-US" altLang="en-US" sz="1000" i="1" u="none" strike="noStrike" cap="none" normalizeH="0" baseline="0" dirty="0" err="1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tropicalis</a:t>
            </a:r>
            <a:endParaRPr kumimoji="0" lang="en-US" altLang="en-US" sz="100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28998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6</Words>
  <Application>Microsoft Macintosh PowerPoint</Application>
  <PresentationFormat>A4 Paper (210x297 mm)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nendu guin</dc:creator>
  <cp:lastModifiedBy>krishnendu guin</cp:lastModifiedBy>
  <cp:revision>1</cp:revision>
  <dcterms:created xsi:type="dcterms:W3CDTF">2020-05-27T11:02:36Z</dcterms:created>
  <dcterms:modified xsi:type="dcterms:W3CDTF">2020-05-27T11:03:32Z</dcterms:modified>
</cp:coreProperties>
</file>